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7"/>
  </p:notesMasterIdLst>
  <p:sldIdLst>
    <p:sldId id="270" r:id="rId2"/>
    <p:sldId id="271" r:id="rId3"/>
    <p:sldId id="272" r:id="rId4"/>
    <p:sldId id="273" r:id="rId5"/>
    <p:sldId id="274" r:id="rId6"/>
    <p:sldId id="275" r:id="rId7"/>
    <p:sldId id="276" r:id="rId8"/>
    <p:sldId id="277" r:id="rId9"/>
    <p:sldId id="285" r:id="rId10"/>
    <p:sldId id="286" r:id="rId11"/>
    <p:sldId id="287" r:id="rId12"/>
    <p:sldId id="259" r:id="rId13"/>
    <p:sldId id="283" r:id="rId14"/>
    <p:sldId id="284" r:id="rId15"/>
    <p:sldId id="282" r:id="rId16"/>
  </p:sldIdLst>
  <p:sldSz cx="7772400" cy="10058400"/>
  <p:notesSz cx="6858000" cy="9144000"/>
  <p:defaultTextStyle>
    <a:defPPr>
      <a:defRPr lang="en-US"/>
    </a:defPPr>
    <a:lvl1pPr marL="0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9863" autoAdjust="0"/>
  </p:normalViewPr>
  <p:slideViewPr>
    <p:cSldViewPr snapToGrid="0" snapToObjects="1">
      <p:cViewPr>
        <p:scale>
          <a:sx n="85" d="100"/>
          <a:sy n="85" d="100"/>
        </p:scale>
        <p:origin x="-88" y="-72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notesMaster" Target="notesMasters/notesMaster1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5CEAFA-FA72-0B4B-9446-8389B4427F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6281F-E86D-924C-BEEB-3E733E97FC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3426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50941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D6281F-E86D-924C-BEEB-3E733E97FC2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4614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D6281F-E86D-924C-BEEB-3E733E97FC2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0168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D6281F-E86D-924C-BEEB-3E733E97FC2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6864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D6281F-E86D-924C-BEEB-3E733E97FC21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5258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D6281F-E86D-924C-BEEB-3E733E97FC2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1817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6"/>
            <a:ext cx="6606540" cy="21560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840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09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4"/>
            <a:ext cx="1748790" cy="85822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4"/>
            <a:ext cx="5116830" cy="85822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045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69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78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2"/>
            <a:ext cx="3432810" cy="663807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2"/>
            <a:ext cx="3432810" cy="663807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911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394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255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94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017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1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7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210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2"/>
            <a:ext cx="6995160" cy="6638079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89960-8469-7745-B2F2-4407440DFEF4}" type="datetimeFigureOut">
              <a:rPr lang="en-US" smtClean="0"/>
              <a:t>10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CD0B9-96A3-9947-853A-BEA9E37B2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45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09412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509412" rtl="0" eaLnBrk="1" latinLnBrk="0" hangingPunct="1">
        <a:spcBef>
          <a:spcPct val="20000"/>
        </a:spcBef>
        <a:buFont typeface="Arial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509412" rtl="0" eaLnBrk="1" latinLnBrk="0" hangingPunct="1">
        <a:spcBef>
          <a:spcPct val="20000"/>
        </a:spcBef>
        <a:buFont typeface="Arial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509412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509412" rtl="0" eaLnBrk="1" latinLnBrk="0" hangingPunct="1">
        <a:spcBef>
          <a:spcPct val="20000"/>
        </a:spcBef>
        <a:buFont typeface="Arial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509412" rtl="0" eaLnBrk="1" latinLnBrk="0" hangingPunct="1">
        <a:spcBef>
          <a:spcPct val="20000"/>
        </a:spcBef>
        <a:buFont typeface="Arial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Relationship Id="rId3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4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5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501" y="1102359"/>
            <a:ext cx="7147898" cy="4921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0"/>
            <a:ext cx="2792224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0</a:t>
            </a:r>
            <a:endParaRPr lang="en-US" dirty="0"/>
          </a:p>
        </p:txBody>
      </p:sp>
      <p:grpSp>
        <p:nvGrpSpPr>
          <p:cNvPr id="5" name="Group 4"/>
          <p:cNvGrpSpPr/>
          <p:nvPr/>
        </p:nvGrpSpPr>
        <p:grpSpPr>
          <a:xfrm>
            <a:off x="1761256" y="1741106"/>
            <a:ext cx="4102405" cy="1762837"/>
            <a:chOff x="110067" y="613833"/>
            <a:chExt cx="4102405" cy="1509882"/>
          </a:xfrm>
        </p:grpSpPr>
        <p:sp>
          <p:nvSpPr>
            <p:cNvPr id="6" name="TextBox 5"/>
            <p:cNvSpPr txBox="1"/>
            <p:nvPr/>
          </p:nvSpPr>
          <p:spPr>
            <a:xfrm>
              <a:off x="727016" y="613833"/>
              <a:ext cx="26427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G580 (</a:t>
              </a:r>
              <a:r>
                <a:rPr lang="en-US" sz="16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if-1::hif-1a::myc</a:t>
              </a:r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8917237">
              <a:off x="329328" y="1553644"/>
              <a:ext cx="23745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8917237">
              <a:off x="740851" y="1573462"/>
              <a:ext cx="23745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8917237">
              <a:off x="960198" y="1837216"/>
              <a:ext cx="2374598" cy="2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 mM 2,4-PDA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8917237">
              <a:off x="1383947" y="1899644"/>
              <a:ext cx="2374598" cy="2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 mM 2,4-PD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8917237">
              <a:off x="1837874" y="1899644"/>
              <a:ext cx="2374598" cy="2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mM pyruvate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0067" y="1658124"/>
              <a:ext cx="23745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7800" y="1108035"/>
              <a:ext cx="6434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IF-1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2000" y="965201"/>
              <a:ext cx="2414016" cy="1066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649716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0"/>
            <a:ext cx="2796207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1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314" y="560055"/>
            <a:ext cx="6259750" cy="613427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794" y="6828426"/>
            <a:ext cx="3421199" cy="286767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78317" y="6828426"/>
            <a:ext cx="4326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7648810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514" y="1027783"/>
            <a:ext cx="7070753" cy="654219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" y="29075"/>
            <a:ext cx="2792224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65528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0713" y="838199"/>
            <a:ext cx="5742940" cy="883947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15105"/>
            <a:ext cx="2792224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61729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880" y="1017693"/>
            <a:ext cx="5738518" cy="71247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796207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17741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2792224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15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0016" y="1432120"/>
            <a:ext cx="4496965" cy="2335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44786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731" y="1137857"/>
            <a:ext cx="7145867" cy="47599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007" y="1049866"/>
            <a:ext cx="7265726" cy="50689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4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" y="915210"/>
            <a:ext cx="7264400" cy="5441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5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366" y="1062216"/>
            <a:ext cx="7332133" cy="4978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6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101" y="1202267"/>
            <a:ext cx="7259596" cy="4758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7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398" y="1095683"/>
            <a:ext cx="7349067" cy="5344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8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0" y="1087038"/>
            <a:ext cx="7366000" cy="5883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743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0"/>
            <a:ext cx="2662231" cy="410654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dirty="0" smtClean="0"/>
              <a:t>Supplemental Figure S9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3604" y="1384323"/>
            <a:ext cx="4212292" cy="6091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2736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97</TotalTime>
  <Words>84</Words>
  <Application>Microsoft Macintosh PowerPoint</Application>
  <PresentationFormat>Custom</PresentationFormat>
  <Paragraphs>29</Paragraphs>
  <Slides>15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THSCS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e Rea</dc:creator>
  <cp:lastModifiedBy>Shane Rea</cp:lastModifiedBy>
  <cp:revision>95</cp:revision>
  <dcterms:created xsi:type="dcterms:W3CDTF">2014-04-08T21:13:59Z</dcterms:created>
  <dcterms:modified xsi:type="dcterms:W3CDTF">2015-10-24T09:35:22Z</dcterms:modified>
</cp:coreProperties>
</file>